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56EFCE-C54F-4FE9-971C-7E17B02C5DD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D8009E-35D2-4B1D-A992-4CBFF41872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CB0EC8-BF23-433A-A9F3-AB699124C5B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A7269F-68E5-43C9-AB11-7D7E8A6ECFA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5C53E2-9D02-4E7F-99EB-2F0731230B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9D4C72-4735-49DA-9C46-6158FF1979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0A33B2-6703-499C-B4E2-CBAC1EEB549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1CED73-41ED-48AD-839E-CBECF868B2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429CA8-7E4F-4852-AB54-EE8B82DEEB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5076D1-CCAB-4A99-B22B-13FD7C1533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CA663F-3ABB-45A6-9D5B-74371050CF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11EAA3-95A6-48A0-9F8E-C2131EDDA8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AF5EB35-8A14-469F-8942-AB0C2CCBE21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644400" y="2800440"/>
          <a:ext cx="5569200" cy="3538440"/>
        </p:xfrm>
        <a:graphic>
          <a:graphicData uri="http://schemas.openxmlformats.org/drawingml/2006/table">
            <a:tbl>
              <a:tblPr/>
              <a:tblGrid>
                <a:gridCol w="1289160"/>
                <a:gridCol w="2184480"/>
                <a:gridCol w="2095560"/>
              </a:tblGrid>
              <a:tr h="2415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rwar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ver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60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MP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GCCACCCATGGTAAACAA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ACTTTGAGAAGGATGGCAAGT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60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MP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GTGTGGTTCAGTTGTGGTG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GACATAGAGGGCATCCA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57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IMP-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CCCACCTCTCCACAAAGTT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CGGAAGCCTCTGAAAGT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60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IMP-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CACTGCATAGCAAGTGGT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GGAGAGCCTGAATCATC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98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PDH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GCCAAGTATGATGACATCAAGAAG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GTCCTCAGTGTAGCCCAAGAT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33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IMP-3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’UTR 1090-109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TAGTATCTTTTTTTCTTTTGTTGTTTGATGGGAAATTGTGACATTCCAAGTTGACTTTTTTTTATTATCGTCGAC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CTTGTCGACGATAATAAAAAAAAGTCAACTTGGAATGTCACAATTTCCCATCAAACAACAAAAGAAAAAAAGAT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068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IMP-3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’UTR 1090-1097 De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TAGTATCTTTTTTTCTTTTGTTGTTTGATGGGAAATTGTGAAGTTGACTTTTTTTTATTATCGTCGACA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CTTGTCGACGATAATAAAAAAAAGTCAACTTCACAATTTCCCATCAAACAACAAAAGAAAAAAAGATA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97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IMP-3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’UTR 1683-168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TAGTGTATTTATCCTCTATTAGTATCATATCGTTTTCATTCCACTTTAGAAACACAGTTAC GTCGAC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CTTGTCGACGTAACTGTGTTTCTAAAGTGGAATGAAAACGATATGATACTAATAGAGGATAAATAC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068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IMP-3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’UTR 1683-1689 De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TAGTGTATTTATCCTCTATTAGTATCATATCGTTTTACTTTAGAAACACAGTTAC GTCGACA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CTTGTCGACGTAACTGTGTTTCTAAAGTAAAACGATATGATACTAATAGAGGATAAATACA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"/>
          <p:cNvSpPr/>
          <p:nvPr/>
        </p:nvSpPr>
        <p:spPr>
          <a:xfrm>
            <a:off x="3022920" y="1887480"/>
            <a:ext cx="810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"/>
              </a:rPr>
              <a:t>Table 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08T17:00:43Z</dcterms:created>
  <dc:creator>germani</dc:creator>
  <dc:description/>
  <dc:language>en-US</dc:language>
  <cp:lastModifiedBy>capogrossi</cp:lastModifiedBy>
  <dcterms:modified xsi:type="dcterms:W3CDTF">2011-01-12T12:29:46Z</dcterms:modified>
  <cp:revision>7</cp:revision>
  <dc:subject/>
  <dc:title>Diapositiva 1</dc:title>
</cp:coreProperties>
</file>